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7185025" cy="45037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2DEEF"/>
    <a:srgbClr val="EAEFF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3" autoAdjust="0"/>
    <p:restoredTop sz="94660"/>
  </p:normalViewPr>
  <p:slideViewPr>
    <p:cSldViewPr snapToGrid="0">
      <p:cViewPr varScale="1">
        <p:scale>
          <a:sx n="86" d="100"/>
          <a:sy n="86" d="100"/>
        </p:scale>
        <p:origin x="1051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98128" y="737070"/>
            <a:ext cx="5388769" cy="1567968"/>
          </a:xfrm>
        </p:spPr>
        <p:txBody>
          <a:bodyPr anchor="b"/>
          <a:lstStyle>
            <a:lvl1pPr algn="ctr">
              <a:defRPr sz="3536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98128" y="2365506"/>
            <a:ext cx="5388769" cy="1087360"/>
          </a:xfrm>
        </p:spPr>
        <p:txBody>
          <a:bodyPr/>
          <a:lstStyle>
            <a:lvl1pPr marL="0" indent="0" algn="ctr">
              <a:buNone/>
              <a:defRPr sz="1414"/>
            </a:lvl1pPr>
            <a:lvl2pPr marL="269428" indent="0" algn="ctr">
              <a:buNone/>
              <a:defRPr sz="1179"/>
            </a:lvl2pPr>
            <a:lvl3pPr marL="538856" indent="0" algn="ctr">
              <a:buNone/>
              <a:defRPr sz="1061"/>
            </a:lvl3pPr>
            <a:lvl4pPr marL="808284" indent="0" algn="ctr">
              <a:buNone/>
              <a:defRPr sz="943"/>
            </a:lvl4pPr>
            <a:lvl5pPr marL="1077712" indent="0" algn="ctr">
              <a:buNone/>
              <a:defRPr sz="943"/>
            </a:lvl5pPr>
            <a:lvl6pPr marL="1347140" indent="0" algn="ctr">
              <a:buNone/>
              <a:defRPr sz="943"/>
            </a:lvl6pPr>
            <a:lvl7pPr marL="1616568" indent="0" algn="ctr">
              <a:buNone/>
              <a:defRPr sz="943"/>
            </a:lvl7pPr>
            <a:lvl8pPr marL="1885996" indent="0" algn="ctr">
              <a:buNone/>
              <a:defRPr sz="943"/>
            </a:lvl8pPr>
            <a:lvl9pPr marL="2155424" indent="0" algn="ctr">
              <a:buNone/>
              <a:defRPr sz="943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7A0E4-B863-4167-9EDE-D951B000D484}" type="datetimeFigureOut">
              <a:rPr lang="en-AU" smtClean="0"/>
              <a:t>4/10/202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A8A3A-1990-45A6-BA48-961091B0416D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030172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7A0E4-B863-4167-9EDE-D951B000D484}" type="datetimeFigureOut">
              <a:rPr lang="en-AU" smtClean="0"/>
              <a:t>4/10/202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A8A3A-1990-45A6-BA48-961091B0416D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097670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141784" y="239782"/>
            <a:ext cx="1549271" cy="3816710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93971" y="239782"/>
            <a:ext cx="4558000" cy="3816710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7A0E4-B863-4167-9EDE-D951B000D484}" type="datetimeFigureOut">
              <a:rPr lang="en-AU" smtClean="0"/>
              <a:t>4/10/202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A8A3A-1990-45A6-BA48-961091B0416D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162998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7A0E4-B863-4167-9EDE-D951B000D484}" type="datetimeFigureOut">
              <a:rPr lang="en-AU" smtClean="0"/>
              <a:t>4/10/202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A8A3A-1990-45A6-BA48-961091B0416D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9415109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0228" y="1122807"/>
            <a:ext cx="6197084" cy="1873430"/>
          </a:xfrm>
        </p:spPr>
        <p:txBody>
          <a:bodyPr anchor="b"/>
          <a:lstStyle>
            <a:lvl1pPr>
              <a:defRPr sz="3536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0228" y="3013961"/>
            <a:ext cx="6197084" cy="985192"/>
          </a:xfrm>
        </p:spPr>
        <p:txBody>
          <a:bodyPr/>
          <a:lstStyle>
            <a:lvl1pPr marL="0" indent="0">
              <a:buNone/>
              <a:defRPr sz="1414">
                <a:solidFill>
                  <a:schemeClr val="tx1">
                    <a:tint val="75000"/>
                  </a:schemeClr>
                </a:solidFill>
              </a:defRPr>
            </a:lvl1pPr>
            <a:lvl2pPr marL="269428" indent="0">
              <a:buNone/>
              <a:defRPr sz="1179">
                <a:solidFill>
                  <a:schemeClr val="tx1">
                    <a:tint val="75000"/>
                  </a:schemeClr>
                </a:solidFill>
              </a:defRPr>
            </a:lvl2pPr>
            <a:lvl3pPr marL="538856" indent="0">
              <a:buNone/>
              <a:defRPr sz="1061">
                <a:solidFill>
                  <a:schemeClr val="tx1">
                    <a:tint val="75000"/>
                  </a:schemeClr>
                </a:solidFill>
              </a:defRPr>
            </a:lvl3pPr>
            <a:lvl4pPr marL="808284" indent="0">
              <a:buNone/>
              <a:defRPr sz="943">
                <a:solidFill>
                  <a:schemeClr val="tx1">
                    <a:tint val="75000"/>
                  </a:schemeClr>
                </a:solidFill>
              </a:defRPr>
            </a:lvl4pPr>
            <a:lvl5pPr marL="1077712" indent="0">
              <a:buNone/>
              <a:defRPr sz="943">
                <a:solidFill>
                  <a:schemeClr val="tx1">
                    <a:tint val="75000"/>
                  </a:schemeClr>
                </a:solidFill>
              </a:defRPr>
            </a:lvl5pPr>
            <a:lvl6pPr marL="1347140" indent="0">
              <a:buNone/>
              <a:defRPr sz="943">
                <a:solidFill>
                  <a:schemeClr val="tx1">
                    <a:tint val="75000"/>
                  </a:schemeClr>
                </a:solidFill>
              </a:defRPr>
            </a:lvl6pPr>
            <a:lvl7pPr marL="1616568" indent="0">
              <a:buNone/>
              <a:defRPr sz="943">
                <a:solidFill>
                  <a:schemeClr val="tx1">
                    <a:tint val="75000"/>
                  </a:schemeClr>
                </a:solidFill>
              </a:defRPr>
            </a:lvl7pPr>
            <a:lvl8pPr marL="1885996" indent="0">
              <a:buNone/>
              <a:defRPr sz="943">
                <a:solidFill>
                  <a:schemeClr val="tx1">
                    <a:tint val="75000"/>
                  </a:schemeClr>
                </a:solidFill>
              </a:defRPr>
            </a:lvl8pPr>
            <a:lvl9pPr marL="2155424" indent="0">
              <a:buNone/>
              <a:defRPr sz="94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7A0E4-B863-4167-9EDE-D951B000D484}" type="datetimeFigureOut">
              <a:rPr lang="en-AU" smtClean="0"/>
              <a:t>4/10/202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A8A3A-1990-45A6-BA48-961091B0416D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588184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93970" y="1198912"/>
            <a:ext cx="3053636" cy="2857580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637419" y="1198912"/>
            <a:ext cx="3053636" cy="2857580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7A0E4-B863-4167-9EDE-D951B000D484}" type="datetimeFigureOut">
              <a:rPr lang="en-AU" smtClean="0"/>
              <a:t>4/10/2024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A8A3A-1990-45A6-BA48-961091B0416D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385138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4906" y="239782"/>
            <a:ext cx="6197084" cy="87051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4907" y="1104042"/>
            <a:ext cx="3039602" cy="541074"/>
          </a:xfrm>
        </p:spPr>
        <p:txBody>
          <a:bodyPr anchor="b"/>
          <a:lstStyle>
            <a:lvl1pPr marL="0" indent="0">
              <a:buNone/>
              <a:defRPr sz="1414" b="1"/>
            </a:lvl1pPr>
            <a:lvl2pPr marL="269428" indent="0">
              <a:buNone/>
              <a:defRPr sz="1179" b="1"/>
            </a:lvl2pPr>
            <a:lvl3pPr marL="538856" indent="0">
              <a:buNone/>
              <a:defRPr sz="1061" b="1"/>
            </a:lvl3pPr>
            <a:lvl4pPr marL="808284" indent="0">
              <a:buNone/>
              <a:defRPr sz="943" b="1"/>
            </a:lvl4pPr>
            <a:lvl5pPr marL="1077712" indent="0">
              <a:buNone/>
              <a:defRPr sz="943" b="1"/>
            </a:lvl5pPr>
            <a:lvl6pPr marL="1347140" indent="0">
              <a:buNone/>
              <a:defRPr sz="943" b="1"/>
            </a:lvl6pPr>
            <a:lvl7pPr marL="1616568" indent="0">
              <a:buNone/>
              <a:defRPr sz="943" b="1"/>
            </a:lvl7pPr>
            <a:lvl8pPr marL="1885996" indent="0">
              <a:buNone/>
              <a:defRPr sz="943" b="1"/>
            </a:lvl8pPr>
            <a:lvl9pPr marL="2155424" indent="0">
              <a:buNone/>
              <a:defRPr sz="943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4907" y="1645115"/>
            <a:ext cx="3039602" cy="2419717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637419" y="1104042"/>
            <a:ext cx="3054571" cy="541074"/>
          </a:xfrm>
        </p:spPr>
        <p:txBody>
          <a:bodyPr anchor="b"/>
          <a:lstStyle>
            <a:lvl1pPr marL="0" indent="0">
              <a:buNone/>
              <a:defRPr sz="1414" b="1"/>
            </a:lvl1pPr>
            <a:lvl2pPr marL="269428" indent="0">
              <a:buNone/>
              <a:defRPr sz="1179" b="1"/>
            </a:lvl2pPr>
            <a:lvl3pPr marL="538856" indent="0">
              <a:buNone/>
              <a:defRPr sz="1061" b="1"/>
            </a:lvl3pPr>
            <a:lvl4pPr marL="808284" indent="0">
              <a:buNone/>
              <a:defRPr sz="943" b="1"/>
            </a:lvl4pPr>
            <a:lvl5pPr marL="1077712" indent="0">
              <a:buNone/>
              <a:defRPr sz="943" b="1"/>
            </a:lvl5pPr>
            <a:lvl6pPr marL="1347140" indent="0">
              <a:buNone/>
              <a:defRPr sz="943" b="1"/>
            </a:lvl6pPr>
            <a:lvl7pPr marL="1616568" indent="0">
              <a:buNone/>
              <a:defRPr sz="943" b="1"/>
            </a:lvl7pPr>
            <a:lvl8pPr marL="1885996" indent="0">
              <a:buNone/>
              <a:defRPr sz="943" b="1"/>
            </a:lvl8pPr>
            <a:lvl9pPr marL="2155424" indent="0">
              <a:buNone/>
              <a:defRPr sz="943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637419" y="1645115"/>
            <a:ext cx="3054571" cy="2419717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7A0E4-B863-4167-9EDE-D951B000D484}" type="datetimeFigureOut">
              <a:rPr lang="en-AU" smtClean="0"/>
              <a:t>4/10/2024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A8A3A-1990-45A6-BA48-961091B0416D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856620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7A0E4-B863-4167-9EDE-D951B000D484}" type="datetimeFigureOut">
              <a:rPr lang="en-AU" smtClean="0"/>
              <a:t>4/10/2024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A8A3A-1990-45A6-BA48-961091B0416D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299079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7A0E4-B863-4167-9EDE-D951B000D484}" type="datetimeFigureOut">
              <a:rPr lang="en-AU" smtClean="0"/>
              <a:t>4/10/2024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A8A3A-1990-45A6-BA48-961091B0416D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919606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4907" y="300249"/>
            <a:ext cx="2317357" cy="1050872"/>
          </a:xfrm>
        </p:spPr>
        <p:txBody>
          <a:bodyPr anchor="b"/>
          <a:lstStyle>
            <a:lvl1pPr>
              <a:defRPr sz="1886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54571" y="648455"/>
            <a:ext cx="3637419" cy="3200573"/>
          </a:xfrm>
        </p:spPr>
        <p:txBody>
          <a:bodyPr/>
          <a:lstStyle>
            <a:lvl1pPr>
              <a:defRPr sz="1886"/>
            </a:lvl1pPr>
            <a:lvl2pPr>
              <a:defRPr sz="1650"/>
            </a:lvl2pPr>
            <a:lvl3pPr>
              <a:defRPr sz="1414"/>
            </a:lvl3pPr>
            <a:lvl4pPr>
              <a:defRPr sz="1179"/>
            </a:lvl4pPr>
            <a:lvl5pPr>
              <a:defRPr sz="1179"/>
            </a:lvl5pPr>
            <a:lvl6pPr>
              <a:defRPr sz="1179"/>
            </a:lvl6pPr>
            <a:lvl7pPr>
              <a:defRPr sz="1179"/>
            </a:lvl7pPr>
            <a:lvl8pPr>
              <a:defRPr sz="1179"/>
            </a:lvl8pPr>
            <a:lvl9pPr>
              <a:defRPr sz="1179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4907" y="1351121"/>
            <a:ext cx="2317357" cy="2503120"/>
          </a:xfrm>
        </p:spPr>
        <p:txBody>
          <a:bodyPr/>
          <a:lstStyle>
            <a:lvl1pPr marL="0" indent="0">
              <a:buNone/>
              <a:defRPr sz="943"/>
            </a:lvl1pPr>
            <a:lvl2pPr marL="269428" indent="0">
              <a:buNone/>
              <a:defRPr sz="825"/>
            </a:lvl2pPr>
            <a:lvl3pPr marL="538856" indent="0">
              <a:buNone/>
              <a:defRPr sz="707"/>
            </a:lvl3pPr>
            <a:lvl4pPr marL="808284" indent="0">
              <a:buNone/>
              <a:defRPr sz="589"/>
            </a:lvl4pPr>
            <a:lvl5pPr marL="1077712" indent="0">
              <a:buNone/>
              <a:defRPr sz="589"/>
            </a:lvl5pPr>
            <a:lvl6pPr marL="1347140" indent="0">
              <a:buNone/>
              <a:defRPr sz="589"/>
            </a:lvl6pPr>
            <a:lvl7pPr marL="1616568" indent="0">
              <a:buNone/>
              <a:defRPr sz="589"/>
            </a:lvl7pPr>
            <a:lvl8pPr marL="1885996" indent="0">
              <a:buNone/>
              <a:defRPr sz="589"/>
            </a:lvl8pPr>
            <a:lvl9pPr marL="2155424" indent="0">
              <a:buNone/>
              <a:defRPr sz="589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7A0E4-B863-4167-9EDE-D951B000D484}" type="datetimeFigureOut">
              <a:rPr lang="en-AU" smtClean="0"/>
              <a:t>4/10/2024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A8A3A-1990-45A6-BA48-961091B0416D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414345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4907" y="300249"/>
            <a:ext cx="2317357" cy="1050872"/>
          </a:xfrm>
        </p:spPr>
        <p:txBody>
          <a:bodyPr anchor="b"/>
          <a:lstStyle>
            <a:lvl1pPr>
              <a:defRPr sz="1886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054571" y="648455"/>
            <a:ext cx="3637419" cy="3200573"/>
          </a:xfrm>
        </p:spPr>
        <p:txBody>
          <a:bodyPr anchor="t"/>
          <a:lstStyle>
            <a:lvl1pPr marL="0" indent="0">
              <a:buNone/>
              <a:defRPr sz="1886"/>
            </a:lvl1pPr>
            <a:lvl2pPr marL="269428" indent="0">
              <a:buNone/>
              <a:defRPr sz="1650"/>
            </a:lvl2pPr>
            <a:lvl3pPr marL="538856" indent="0">
              <a:buNone/>
              <a:defRPr sz="1414"/>
            </a:lvl3pPr>
            <a:lvl4pPr marL="808284" indent="0">
              <a:buNone/>
              <a:defRPr sz="1179"/>
            </a:lvl4pPr>
            <a:lvl5pPr marL="1077712" indent="0">
              <a:buNone/>
              <a:defRPr sz="1179"/>
            </a:lvl5pPr>
            <a:lvl6pPr marL="1347140" indent="0">
              <a:buNone/>
              <a:defRPr sz="1179"/>
            </a:lvl6pPr>
            <a:lvl7pPr marL="1616568" indent="0">
              <a:buNone/>
              <a:defRPr sz="1179"/>
            </a:lvl7pPr>
            <a:lvl8pPr marL="1885996" indent="0">
              <a:buNone/>
              <a:defRPr sz="1179"/>
            </a:lvl8pPr>
            <a:lvl9pPr marL="2155424" indent="0">
              <a:buNone/>
              <a:defRPr sz="1179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4907" y="1351121"/>
            <a:ext cx="2317357" cy="2503120"/>
          </a:xfrm>
        </p:spPr>
        <p:txBody>
          <a:bodyPr/>
          <a:lstStyle>
            <a:lvl1pPr marL="0" indent="0">
              <a:buNone/>
              <a:defRPr sz="943"/>
            </a:lvl1pPr>
            <a:lvl2pPr marL="269428" indent="0">
              <a:buNone/>
              <a:defRPr sz="825"/>
            </a:lvl2pPr>
            <a:lvl3pPr marL="538856" indent="0">
              <a:buNone/>
              <a:defRPr sz="707"/>
            </a:lvl3pPr>
            <a:lvl4pPr marL="808284" indent="0">
              <a:buNone/>
              <a:defRPr sz="589"/>
            </a:lvl4pPr>
            <a:lvl5pPr marL="1077712" indent="0">
              <a:buNone/>
              <a:defRPr sz="589"/>
            </a:lvl5pPr>
            <a:lvl6pPr marL="1347140" indent="0">
              <a:buNone/>
              <a:defRPr sz="589"/>
            </a:lvl6pPr>
            <a:lvl7pPr marL="1616568" indent="0">
              <a:buNone/>
              <a:defRPr sz="589"/>
            </a:lvl7pPr>
            <a:lvl8pPr marL="1885996" indent="0">
              <a:buNone/>
              <a:defRPr sz="589"/>
            </a:lvl8pPr>
            <a:lvl9pPr marL="2155424" indent="0">
              <a:buNone/>
              <a:defRPr sz="589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7A0E4-B863-4167-9EDE-D951B000D484}" type="datetimeFigureOut">
              <a:rPr lang="en-AU" smtClean="0"/>
              <a:t>4/10/2024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A8A3A-1990-45A6-BA48-961091B0416D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298231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93971" y="239782"/>
            <a:ext cx="6197084" cy="87051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3971" y="1198912"/>
            <a:ext cx="6197084" cy="285758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93970" y="4174298"/>
            <a:ext cx="1616631" cy="23978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0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D7A0E4-B863-4167-9EDE-D951B000D484}" type="datetimeFigureOut">
              <a:rPr lang="en-AU" smtClean="0"/>
              <a:t>4/10/202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80040" y="4174298"/>
            <a:ext cx="2424946" cy="23978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70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074424" y="4174298"/>
            <a:ext cx="1616631" cy="23978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70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6A8A3A-1990-45A6-BA48-961091B0416D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782431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538856" rtl="0" eaLnBrk="1" latinLnBrk="0" hangingPunct="1">
        <a:lnSpc>
          <a:spcPct val="90000"/>
        </a:lnSpc>
        <a:spcBef>
          <a:spcPct val="0"/>
        </a:spcBef>
        <a:buNone/>
        <a:defRPr sz="259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34714" indent="-134714" algn="l" defTabSz="538856" rtl="0" eaLnBrk="1" latinLnBrk="0" hangingPunct="1">
        <a:lnSpc>
          <a:spcPct val="90000"/>
        </a:lnSpc>
        <a:spcBef>
          <a:spcPts val="589"/>
        </a:spcBef>
        <a:buFont typeface="Arial" panose="020B0604020202020204" pitchFamily="34" charset="0"/>
        <a:buChar char="•"/>
        <a:defRPr sz="1650" kern="1200">
          <a:solidFill>
            <a:schemeClr val="tx1"/>
          </a:solidFill>
          <a:latin typeface="+mn-lt"/>
          <a:ea typeface="+mn-ea"/>
          <a:cs typeface="+mn-cs"/>
        </a:defRPr>
      </a:lvl1pPr>
      <a:lvl2pPr marL="404142" indent="-134714" algn="l" defTabSz="538856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sz="1414" kern="1200">
          <a:solidFill>
            <a:schemeClr val="tx1"/>
          </a:solidFill>
          <a:latin typeface="+mn-lt"/>
          <a:ea typeface="+mn-ea"/>
          <a:cs typeface="+mn-cs"/>
        </a:defRPr>
      </a:lvl2pPr>
      <a:lvl3pPr marL="673570" indent="-134714" algn="l" defTabSz="538856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sz="1179" kern="1200">
          <a:solidFill>
            <a:schemeClr val="tx1"/>
          </a:solidFill>
          <a:latin typeface="+mn-lt"/>
          <a:ea typeface="+mn-ea"/>
          <a:cs typeface="+mn-cs"/>
        </a:defRPr>
      </a:lvl3pPr>
      <a:lvl4pPr marL="942998" indent="-134714" algn="l" defTabSz="538856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sz="1061" kern="1200">
          <a:solidFill>
            <a:schemeClr val="tx1"/>
          </a:solidFill>
          <a:latin typeface="+mn-lt"/>
          <a:ea typeface="+mn-ea"/>
          <a:cs typeface="+mn-cs"/>
        </a:defRPr>
      </a:lvl4pPr>
      <a:lvl5pPr marL="1212426" indent="-134714" algn="l" defTabSz="538856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sz="1061" kern="1200">
          <a:solidFill>
            <a:schemeClr val="tx1"/>
          </a:solidFill>
          <a:latin typeface="+mn-lt"/>
          <a:ea typeface="+mn-ea"/>
          <a:cs typeface="+mn-cs"/>
        </a:defRPr>
      </a:lvl5pPr>
      <a:lvl6pPr marL="1481854" indent="-134714" algn="l" defTabSz="538856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sz="1061" kern="1200">
          <a:solidFill>
            <a:schemeClr val="tx1"/>
          </a:solidFill>
          <a:latin typeface="+mn-lt"/>
          <a:ea typeface="+mn-ea"/>
          <a:cs typeface="+mn-cs"/>
        </a:defRPr>
      </a:lvl6pPr>
      <a:lvl7pPr marL="1751282" indent="-134714" algn="l" defTabSz="538856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sz="1061" kern="1200">
          <a:solidFill>
            <a:schemeClr val="tx1"/>
          </a:solidFill>
          <a:latin typeface="+mn-lt"/>
          <a:ea typeface="+mn-ea"/>
          <a:cs typeface="+mn-cs"/>
        </a:defRPr>
      </a:lvl7pPr>
      <a:lvl8pPr marL="2020710" indent="-134714" algn="l" defTabSz="538856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sz="1061" kern="1200">
          <a:solidFill>
            <a:schemeClr val="tx1"/>
          </a:solidFill>
          <a:latin typeface="+mn-lt"/>
          <a:ea typeface="+mn-ea"/>
          <a:cs typeface="+mn-cs"/>
        </a:defRPr>
      </a:lvl8pPr>
      <a:lvl9pPr marL="2290138" indent="-134714" algn="l" defTabSz="538856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sz="106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38856" rtl="0" eaLnBrk="1" latinLnBrk="0" hangingPunct="1">
        <a:defRPr sz="1061" kern="1200">
          <a:solidFill>
            <a:schemeClr val="tx1"/>
          </a:solidFill>
          <a:latin typeface="+mn-lt"/>
          <a:ea typeface="+mn-ea"/>
          <a:cs typeface="+mn-cs"/>
        </a:defRPr>
      </a:lvl1pPr>
      <a:lvl2pPr marL="269428" algn="l" defTabSz="538856" rtl="0" eaLnBrk="1" latinLnBrk="0" hangingPunct="1">
        <a:defRPr sz="1061" kern="1200">
          <a:solidFill>
            <a:schemeClr val="tx1"/>
          </a:solidFill>
          <a:latin typeface="+mn-lt"/>
          <a:ea typeface="+mn-ea"/>
          <a:cs typeface="+mn-cs"/>
        </a:defRPr>
      </a:lvl2pPr>
      <a:lvl3pPr marL="538856" algn="l" defTabSz="538856" rtl="0" eaLnBrk="1" latinLnBrk="0" hangingPunct="1">
        <a:defRPr sz="1061" kern="1200">
          <a:solidFill>
            <a:schemeClr val="tx1"/>
          </a:solidFill>
          <a:latin typeface="+mn-lt"/>
          <a:ea typeface="+mn-ea"/>
          <a:cs typeface="+mn-cs"/>
        </a:defRPr>
      </a:lvl3pPr>
      <a:lvl4pPr marL="808284" algn="l" defTabSz="538856" rtl="0" eaLnBrk="1" latinLnBrk="0" hangingPunct="1">
        <a:defRPr sz="1061" kern="1200">
          <a:solidFill>
            <a:schemeClr val="tx1"/>
          </a:solidFill>
          <a:latin typeface="+mn-lt"/>
          <a:ea typeface="+mn-ea"/>
          <a:cs typeface="+mn-cs"/>
        </a:defRPr>
      </a:lvl4pPr>
      <a:lvl5pPr marL="1077712" algn="l" defTabSz="538856" rtl="0" eaLnBrk="1" latinLnBrk="0" hangingPunct="1">
        <a:defRPr sz="1061" kern="1200">
          <a:solidFill>
            <a:schemeClr val="tx1"/>
          </a:solidFill>
          <a:latin typeface="+mn-lt"/>
          <a:ea typeface="+mn-ea"/>
          <a:cs typeface="+mn-cs"/>
        </a:defRPr>
      </a:lvl5pPr>
      <a:lvl6pPr marL="1347140" algn="l" defTabSz="538856" rtl="0" eaLnBrk="1" latinLnBrk="0" hangingPunct="1">
        <a:defRPr sz="1061" kern="1200">
          <a:solidFill>
            <a:schemeClr val="tx1"/>
          </a:solidFill>
          <a:latin typeface="+mn-lt"/>
          <a:ea typeface="+mn-ea"/>
          <a:cs typeface="+mn-cs"/>
        </a:defRPr>
      </a:lvl6pPr>
      <a:lvl7pPr marL="1616568" algn="l" defTabSz="538856" rtl="0" eaLnBrk="1" latinLnBrk="0" hangingPunct="1">
        <a:defRPr sz="1061" kern="1200">
          <a:solidFill>
            <a:schemeClr val="tx1"/>
          </a:solidFill>
          <a:latin typeface="+mn-lt"/>
          <a:ea typeface="+mn-ea"/>
          <a:cs typeface="+mn-cs"/>
        </a:defRPr>
      </a:lvl7pPr>
      <a:lvl8pPr marL="1885996" algn="l" defTabSz="538856" rtl="0" eaLnBrk="1" latinLnBrk="0" hangingPunct="1">
        <a:defRPr sz="1061" kern="1200">
          <a:solidFill>
            <a:schemeClr val="tx1"/>
          </a:solidFill>
          <a:latin typeface="+mn-lt"/>
          <a:ea typeface="+mn-ea"/>
          <a:cs typeface="+mn-cs"/>
        </a:defRPr>
      </a:lvl8pPr>
      <a:lvl9pPr marL="2155424" algn="l" defTabSz="538856" rtl="0" eaLnBrk="1" latinLnBrk="0" hangingPunct="1">
        <a:defRPr sz="106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19398692"/>
              </p:ext>
            </p:extLst>
          </p:nvPr>
        </p:nvGraphicFramePr>
        <p:xfrm>
          <a:off x="0" y="-17462"/>
          <a:ext cx="7186170" cy="4503467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287454">
                  <a:extLst>
                    <a:ext uri="{9D8B030D-6E8A-4147-A177-3AD203B41FA5}">
                      <a16:colId xmlns:a16="http://schemas.microsoft.com/office/drawing/2014/main" val="1422511156"/>
                    </a:ext>
                  </a:extLst>
                </a:gridCol>
                <a:gridCol w="450416">
                  <a:extLst>
                    <a:ext uri="{9D8B030D-6E8A-4147-A177-3AD203B41FA5}">
                      <a16:colId xmlns:a16="http://schemas.microsoft.com/office/drawing/2014/main" val="375144800"/>
                    </a:ext>
                  </a:extLst>
                </a:gridCol>
                <a:gridCol w="812800">
                  <a:extLst>
                    <a:ext uri="{9D8B030D-6E8A-4147-A177-3AD203B41FA5}">
                      <a16:colId xmlns:a16="http://schemas.microsoft.com/office/drawing/2014/main" val="2144639985"/>
                    </a:ext>
                  </a:extLst>
                </a:gridCol>
                <a:gridCol w="647700">
                  <a:extLst>
                    <a:ext uri="{9D8B030D-6E8A-4147-A177-3AD203B41FA5}">
                      <a16:colId xmlns:a16="http://schemas.microsoft.com/office/drawing/2014/main" val="3610476337"/>
                    </a:ext>
                  </a:extLst>
                </a:gridCol>
                <a:gridCol w="1257300">
                  <a:extLst>
                    <a:ext uri="{9D8B030D-6E8A-4147-A177-3AD203B41FA5}">
                      <a16:colId xmlns:a16="http://schemas.microsoft.com/office/drawing/2014/main" val="602922004"/>
                    </a:ext>
                  </a:extLst>
                </a:gridCol>
                <a:gridCol w="1371600">
                  <a:extLst>
                    <a:ext uri="{9D8B030D-6E8A-4147-A177-3AD203B41FA5}">
                      <a16:colId xmlns:a16="http://schemas.microsoft.com/office/drawing/2014/main" val="3841561200"/>
                    </a:ext>
                  </a:extLst>
                </a:gridCol>
                <a:gridCol w="1358900">
                  <a:extLst>
                    <a:ext uri="{9D8B030D-6E8A-4147-A177-3AD203B41FA5}">
                      <a16:colId xmlns:a16="http://schemas.microsoft.com/office/drawing/2014/main" val="2909165291"/>
                    </a:ext>
                  </a:extLst>
                </a:gridCol>
              </a:tblGrid>
              <a:tr h="384606">
                <a:tc gridSpan="4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Pandemic Phase</a:t>
                      </a:r>
                      <a:endParaRPr lang="en-AU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Sensitivity</a:t>
                      </a:r>
                      <a:endParaRPr lang="en-AU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Positive predictive value</a:t>
                      </a:r>
                      <a:endParaRPr lang="en-AU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Predictive performance</a:t>
                      </a:r>
                      <a:endParaRPr lang="en-AU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/>
                </a:tc>
                <a:extLst>
                  <a:ext uri="{0D108BD9-81ED-4DB2-BD59-A6C34878D82A}">
                    <a16:rowId xmlns:a16="http://schemas.microsoft.com/office/drawing/2014/main" val="3291645922"/>
                  </a:ext>
                </a:extLst>
              </a:tr>
              <a:tr h="252702"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Contingency Table</a:t>
                      </a:r>
                      <a:endParaRPr lang="en-AU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b="1" kern="1200" dirty="0">
                          <a:solidFill>
                            <a:schemeClr val="bg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Quarantined</a:t>
                      </a:r>
                      <a:endParaRPr lang="en-AU" sz="1200" b="1" kern="1200" dirty="0">
                        <a:solidFill>
                          <a:schemeClr val="bg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7387" marR="67387" marT="0" marB="0" anchor="ctr">
                    <a:solidFill>
                      <a:schemeClr val="accent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</a:rPr>
                        <a:t>Infections captured (%)</a:t>
                      </a:r>
                      <a:endParaRPr lang="en-AU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>
                    <a:solidFill>
                      <a:srgbClr val="EAEFF7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</a:rPr>
                        <a:t>Infections in quarantine population (%)</a:t>
                      </a:r>
                      <a:endParaRPr lang="en-AU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>
                    <a:solidFill>
                      <a:srgbClr val="EAEFF7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</a:rPr>
                        <a:t>Weighted F</a:t>
                      </a:r>
                      <a:r>
                        <a:rPr lang="en-AU" sz="1200" baseline="-25000" dirty="0">
                          <a:effectLst/>
                        </a:rPr>
                        <a:t>β</a:t>
                      </a:r>
                      <a:r>
                        <a:rPr lang="en-AU" sz="1200" baseline="30000" dirty="0">
                          <a:effectLst/>
                        </a:rPr>
                        <a:t>e</a:t>
                      </a:r>
                      <a:r>
                        <a:rPr lang="en-AU" sz="1200" dirty="0">
                          <a:effectLst/>
                        </a:rPr>
                        <a:t> score</a:t>
                      </a:r>
                      <a:endParaRPr lang="en-AU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72861039"/>
                  </a:ext>
                </a:extLst>
              </a:tr>
              <a:tr h="243342"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Yes: </a:t>
                      </a:r>
                      <a:r>
                        <a:rPr lang="en-US" sz="1200" dirty="0" smtClean="0">
                          <a:effectLst/>
                        </a:rPr>
                        <a:t>+      </a:t>
                      </a:r>
                      <a:r>
                        <a:rPr lang="en-US" sz="1200" dirty="0">
                          <a:effectLst/>
                        </a:rPr>
                        <a:t>No: –</a:t>
                      </a:r>
                      <a:endParaRPr lang="en-AU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+</a:t>
                      </a:r>
                      <a:endParaRPr lang="en-AU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–</a:t>
                      </a:r>
                      <a:endParaRPr lang="en-AU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/>
                </a:tc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74861532"/>
                  </a:ext>
                </a:extLst>
              </a:tr>
              <a:tr h="233983">
                <a:tc row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Infected</a:t>
                      </a:r>
                      <a:endParaRPr lang="en-AU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+</a:t>
                      </a:r>
                      <a:endParaRPr lang="en-AU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TP</a:t>
                      </a:r>
                      <a:r>
                        <a:rPr lang="en-US" sz="1200" baseline="30000" dirty="0">
                          <a:effectLst/>
                        </a:rPr>
                        <a:t>a</a:t>
                      </a:r>
                      <a:endParaRPr lang="en-AU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FN</a:t>
                      </a:r>
                      <a:r>
                        <a:rPr lang="en-US" sz="1200" baseline="30000">
                          <a:effectLst/>
                        </a:rPr>
                        <a:t>b</a:t>
                      </a:r>
                      <a:endParaRPr lang="en-AU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/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TP</a:t>
                      </a:r>
                      <a:r>
                        <a:rPr lang="en-US" sz="1200" baseline="30000" dirty="0">
                          <a:effectLst/>
                        </a:rPr>
                        <a:t>b</a:t>
                      </a:r>
                      <a:r>
                        <a:rPr lang="en-US" sz="1200" dirty="0">
                          <a:effectLst/>
                        </a:rPr>
                        <a:t>/(TP+FN</a:t>
                      </a:r>
                      <a:r>
                        <a:rPr lang="en-US" sz="1200" baseline="30000" dirty="0">
                          <a:effectLst/>
                        </a:rPr>
                        <a:t>c</a:t>
                      </a:r>
                      <a:r>
                        <a:rPr lang="en-US" sz="1200" dirty="0">
                          <a:effectLst/>
                        </a:rPr>
                        <a:t>)</a:t>
                      </a:r>
                      <a:endParaRPr lang="en-AU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/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TP/(TP+FP</a:t>
                      </a:r>
                      <a:r>
                        <a:rPr lang="en-US" sz="1200" baseline="30000" dirty="0">
                          <a:effectLst/>
                        </a:rPr>
                        <a:t>d</a:t>
                      </a:r>
                      <a:r>
                        <a:rPr lang="en-US" sz="1200" dirty="0">
                          <a:effectLst/>
                        </a:rPr>
                        <a:t>)</a:t>
                      </a:r>
                      <a:endParaRPr lang="en-AU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/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([5TP)/</a:t>
                      </a:r>
                      <a:endParaRPr lang="en-AU" sz="1200" dirty="0"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(5TP+4FN+FP)</a:t>
                      </a:r>
                      <a:endParaRPr lang="en-AU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/>
                </a:tc>
                <a:extLst>
                  <a:ext uri="{0D108BD9-81ED-4DB2-BD59-A6C34878D82A}">
                    <a16:rowId xmlns:a16="http://schemas.microsoft.com/office/drawing/2014/main" val="3456666293"/>
                  </a:ext>
                </a:extLst>
              </a:tr>
              <a:tr h="243342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–</a:t>
                      </a:r>
                      <a:endParaRPr lang="en-AU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FP</a:t>
                      </a:r>
                      <a:r>
                        <a:rPr lang="en-US" sz="1200" baseline="30000" dirty="0">
                          <a:effectLst/>
                        </a:rPr>
                        <a:t>c</a:t>
                      </a:r>
                      <a:endParaRPr lang="en-AU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TN</a:t>
                      </a:r>
                      <a:endParaRPr lang="en-AU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>
                    <a:solidFill>
                      <a:srgbClr val="D2DEE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98726010"/>
                  </a:ext>
                </a:extLst>
              </a:tr>
              <a:tr h="192303">
                <a:tc gridSpan="7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Phase 1</a:t>
                      </a:r>
                      <a:endParaRPr lang="en-AU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86240180"/>
                  </a:ext>
                </a:extLst>
              </a:tr>
              <a:tr h="192308">
                <a:tc row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 Infected</a:t>
                      </a:r>
                      <a:endParaRPr lang="en-AU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+</a:t>
                      </a:r>
                      <a:endParaRPr lang="en-AU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401</a:t>
                      </a:r>
                      <a:endParaRPr lang="en-AU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1686</a:t>
                      </a:r>
                      <a:endParaRPr lang="en-AU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/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effectLst/>
                        </a:rPr>
                        <a:t>19.2%</a:t>
                      </a:r>
                      <a:endParaRPr lang="en-AU" sz="1200" dirty="0" smtClean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>
                    <a:solidFill>
                      <a:srgbClr val="EAEFF7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effectLst/>
                        </a:rPr>
                        <a:t>4.69%</a:t>
                      </a:r>
                      <a:endParaRPr lang="en-AU" sz="1200" dirty="0" smtClean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>
                    <a:solidFill>
                      <a:srgbClr val="EAEFF7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effectLst/>
                        </a:rPr>
                        <a:t>0.119</a:t>
                      </a:r>
                      <a:endParaRPr lang="en-AU" sz="1200" dirty="0" smtClean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37145207"/>
                  </a:ext>
                </a:extLst>
              </a:tr>
              <a:tr h="256718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–</a:t>
                      </a:r>
                      <a:endParaRPr lang="en-AU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8149</a:t>
                      </a:r>
                      <a:endParaRPr lang="en-AU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N/A</a:t>
                      </a:r>
                      <a:endParaRPr lang="en-AU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>
                    <a:solidFill>
                      <a:srgbClr val="EAEFF7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76221833"/>
                  </a:ext>
                </a:extLst>
              </a:tr>
              <a:tr h="196266">
                <a:tc gridSpan="7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Phase 2</a:t>
                      </a:r>
                      <a:endParaRPr lang="en-AU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20206610"/>
                  </a:ext>
                </a:extLst>
              </a:tr>
              <a:tr h="195987">
                <a:tc row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Infected</a:t>
                      </a:r>
                      <a:endParaRPr lang="en-AU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+</a:t>
                      </a:r>
                      <a:endParaRPr lang="en-AU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5810</a:t>
                      </a:r>
                      <a:endParaRPr lang="en-AU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11,004</a:t>
                      </a:r>
                      <a:endParaRPr lang="en-AU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>
                    <a:solidFill>
                      <a:srgbClr val="D2DEEF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effectLst/>
                        </a:rPr>
                        <a:t>34.6%</a:t>
                      </a:r>
                      <a:endParaRPr lang="en-AU" sz="1200" dirty="0" smtClean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>
                    <a:solidFill>
                      <a:srgbClr val="D2DEEF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effectLst/>
                        </a:rPr>
                        <a:t>14.6%</a:t>
                      </a:r>
                      <a:endParaRPr lang="en-AU" sz="1200" dirty="0" smtClean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>
                    <a:solidFill>
                      <a:srgbClr val="D2DEEF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effectLst/>
                        </a:rPr>
                        <a:t>0.272</a:t>
                      </a:r>
                      <a:endParaRPr lang="en-AU" sz="1200" dirty="0" smtClean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>
                    <a:solidFill>
                      <a:srgbClr val="D2DEE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57440089"/>
                  </a:ext>
                </a:extLst>
              </a:tr>
              <a:tr h="192303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–</a:t>
                      </a:r>
                      <a:endParaRPr lang="en-AU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33,877</a:t>
                      </a:r>
                      <a:endParaRPr lang="en-AU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N/A</a:t>
                      </a:r>
                      <a:endParaRPr lang="en-AU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>
                    <a:solidFill>
                      <a:srgbClr val="D2DEE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19197169"/>
                  </a:ext>
                </a:extLst>
              </a:tr>
              <a:tr h="205905">
                <a:tc gridSpan="7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Phase 3</a:t>
                      </a:r>
                      <a:endParaRPr lang="en-AU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2178226"/>
                  </a:ext>
                </a:extLst>
              </a:tr>
              <a:tr h="205905">
                <a:tc row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Infected</a:t>
                      </a:r>
                      <a:endParaRPr lang="en-AU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+</a:t>
                      </a:r>
                      <a:endParaRPr lang="en-AU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3492</a:t>
                      </a:r>
                      <a:endParaRPr lang="en-AU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5311</a:t>
                      </a:r>
                      <a:endParaRPr lang="en-AU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/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effectLst/>
                        </a:rPr>
                        <a:t>39.7%</a:t>
                      </a:r>
                      <a:endParaRPr lang="en-AU" sz="1200" dirty="0" smtClean="0">
                        <a:effectLst/>
                      </a:endParaRPr>
                    </a:p>
                  </a:txBody>
                  <a:tcPr marL="67387" marR="67387" marT="0" marB="0" anchor="ctr">
                    <a:solidFill>
                      <a:srgbClr val="EAEFF7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effectLst/>
                        </a:rPr>
                        <a:t>21.2%</a:t>
                      </a:r>
                      <a:endParaRPr lang="en-AU" sz="1200" dirty="0" smtClean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>
                    <a:solidFill>
                      <a:srgbClr val="EAEFF7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effectLst/>
                        </a:rPr>
                        <a:t>0.338</a:t>
                      </a:r>
                      <a:endParaRPr lang="en-AU" sz="1200" dirty="0" smtClean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91788106"/>
                  </a:ext>
                </a:extLst>
              </a:tr>
              <a:tr h="205905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–</a:t>
                      </a:r>
                      <a:endParaRPr lang="en-AU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12,970</a:t>
                      </a:r>
                      <a:endParaRPr lang="en-AU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N/A</a:t>
                      </a:r>
                      <a:endParaRPr lang="en-AU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>
                    <a:solidFill>
                      <a:srgbClr val="EAEFF7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AU" dirty="0"/>
                    </a:p>
                  </a:txBody>
                  <a:tcPr marL="67387" marR="67387" marT="0" marB="0" anchor="ctr">
                    <a:solidFill>
                      <a:srgbClr val="EAEFF7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AU" dirty="0"/>
                    </a:p>
                  </a:txBody>
                  <a:tcPr marL="67387" marR="67387" marT="0" marB="0" anchor="ctr">
                    <a:solidFill>
                      <a:srgbClr val="EAEFF7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AU" dirty="0"/>
                    </a:p>
                  </a:txBody>
                  <a:tcPr marL="67387" marR="67387" marT="0" marB="0" anchor="ctr"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17174711"/>
                  </a:ext>
                </a:extLst>
              </a:tr>
              <a:tr h="175283">
                <a:tc gridSpan="7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Phase </a:t>
                      </a:r>
                      <a:r>
                        <a:rPr lang="en-US" sz="1200" dirty="0" smtClean="0">
                          <a:effectLst/>
                        </a:rPr>
                        <a:t>4</a:t>
                      </a:r>
                      <a:endParaRPr lang="en-AU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14950035"/>
                  </a:ext>
                </a:extLst>
              </a:tr>
              <a:tr h="187240">
                <a:tc row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Infected</a:t>
                      </a:r>
                      <a:endParaRPr lang="en-AU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+</a:t>
                      </a:r>
                      <a:endParaRPr lang="en-AU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2219</a:t>
                      </a:r>
                      <a:endParaRPr lang="en-AU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20,359</a:t>
                      </a:r>
                      <a:endParaRPr lang="en-AU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/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dirty="0" smtClean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9.8%</a:t>
                      </a:r>
                      <a:endParaRPr lang="en-AU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>
                    <a:solidFill>
                      <a:srgbClr val="D2DEEF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effectLst/>
                        </a:rPr>
                        <a:t>25.9</a:t>
                      </a:r>
                      <a:r>
                        <a:rPr lang="en-US" sz="1200" dirty="0" smtClean="0">
                          <a:effectLst/>
                        </a:rPr>
                        <a:t>%</a:t>
                      </a:r>
                      <a:endParaRPr lang="en-AU" sz="1200" dirty="0" smtClean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>
                    <a:solidFill>
                      <a:srgbClr val="D2DEEF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effectLst/>
                        </a:rPr>
                        <a:t>0.112</a:t>
                      </a:r>
                      <a:endParaRPr lang="en-AU" sz="1200" dirty="0" smtClean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>
                    <a:solidFill>
                      <a:srgbClr val="D2DEE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78628638"/>
                  </a:ext>
                </a:extLst>
              </a:tr>
              <a:tr h="192303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–</a:t>
                      </a:r>
                      <a:endParaRPr lang="en-AU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6336</a:t>
                      </a:r>
                      <a:endParaRPr lang="en-AU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N/A</a:t>
                      </a:r>
                      <a:endParaRPr lang="en-AU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>
                    <a:solidFill>
                      <a:srgbClr val="D2DEE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97244959"/>
                  </a:ext>
                </a:extLst>
              </a:tr>
              <a:tr h="208746">
                <a:tc gridSpan="7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Phase 5</a:t>
                      </a:r>
                      <a:endParaRPr lang="en-AU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49612864"/>
                  </a:ext>
                </a:extLst>
              </a:tr>
              <a:tr h="202226">
                <a:tc row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Infected</a:t>
                      </a:r>
                      <a:endParaRPr lang="en-AU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+</a:t>
                      </a:r>
                      <a:endParaRPr lang="en-AU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1025</a:t>
                      </a:r>
                      <a:endParaRPr lang="en-AU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146,841</a:t>
                      </a:r>
                      <a:endParaRPr lang="en-AU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/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effectLst/>
                        </a:rPr>
                        <a:t>0.7%</a:t>
                      </a:r>
                      <a:endParaRPr lang="en-AU" sz="1200" dirty="0" smtClean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>
                    <a:solidFill>
                      <a:srgbClr val="EAEFF7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effectLst/>
                        </a:rPr>
                        <a:t>19.0%</a:t>
                      </a:r>
                      <a:endParaRPr lang="en-AU" sz="1200" dirty="0" smtClean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>
                    <a:solidFill>
                      <a:srgbClr val="EAEFF7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effectLst/>
                        </a:rPr>
                        <a:t>0.009</a:t>
                      </a:r>
                      <a:endParaRPr lang="en-AU" sz="1200" dirty="0" smtClean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28347086"/>
                  </a:ext>
                </a:extLst>
              </a:tr>
              <a:tr h="192303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–</a:t>
                      </a:r>
                      <a:endParaRPr lang="en-AU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4362</a:t>
                      </a:r>
                      <a:endParaRPr lang="en-AU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N/A</a:t>
                      </a:r>
                      <a:endParaRPr lang="en-AU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387" marR="67387" marT="0" marB="0" anchor="ctr">
                    <a:solidFill>
                      <a:srgbClr val="EAEFF7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75260518"/>
                  </a:ext>
                </a:extLst>
              </a:tr>
            </a:tbl>
          </a:graphicData>
        </a:graphic>
      </p:graphicFrame>
      <p:sp>
        <p:nvSpPr>
          <p:cNvPr id="5" name="Rectangle 1"/>
          <p:cNvSpPr>
            <a:spLocks noChangeArrowheads="1"/>
          </p:cNvSpPr>
          <p:nvPr/>
        </p:nvSpPr>
        <p:spPr bwMode="auto">
          <a:xfrm>
            <a:off x="-1535635" y="488708"/>
            <a:ext cx="184731" cy="369332"/>
          </a:xfrm>
          <a:prstGeom prst="rect">
            <a:avLst/>
          </a:prstGeom>
          <a:solidFill>
            <a:srgbClr val="000000"/>
          </a:solidFill>
          <a:ln w="9525">
            <a:solidFill>
              <a:schemeClr val="tx1"/>
            </a:solidFill>
            <a:prstDash val="solid"/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869253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22</Words>
  <Application>Microsoft Office PowerPoint</Application>
  <PresentationFormat>Benutzerdefiniert</PresentationFormat>
  <Paragraphs>78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</vt:lpstr>
      <vt:lpstr>PowerPoint-Präsentation</vt:lpstr>
    </vt:vector>
  </TitlesOfParts>
  <Company>Rhein-Neckar-Krei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yer, Christopher</dc:creator>
  <cp:lastModifiedBy>Dyer, Christopher</cp:lastModifiedBy>
  <cp:revision>5</cp:revision>
  <dcterms:created xsi:type="dcterms:W3CDTF">2024-09-16T06:05:04Z</dcterms:created>
  <dcterms:modified xsi:type="dcterms:W3CDTF">2024-10-04T12:22:59Z</dcterms:modified>
</cp:coreProperties>
</file>